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wmf" ContentType="image/x-wmf"/>
  <Override PartName="/ppt/media/image5.jpeg" ContentType="image/jpeg"/>
  <Override PartName="/ppt/media/image6.jpeg" ContentType="image/jpeg"/>
  <Override PartName="/ppt/media/image7.jpeg" ContentType="image/jpe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A68F0-B871-4E89-9B41-B07EEFF61E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EA93B-5DC5-4813-8840-BADFB2B6AF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A0802-AC03-45E2-82DB-BA3A2537E3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6DBFD-0696-45F7-9FDC-74290CD7CE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83C29-F566-443B-8248-5D5523CC46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C69F5-57CA-4349-812D-70B0977A79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AF262-6F8D-4248-99A3-397E3569A3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9C8FA-44A8-4E84-8579-4CBFF721D5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65658-9908-4616-B299-980C8049E3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70702-850B-402A-AA63-554280755C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5DE17-4D08-4D29-9A36-07CA932B8A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8D1A7-C706-482A-B10A-2148A9883A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6310B6-AD24-4648-A53C-3AA0867F1707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oleObject" Target="../embeddings/oleObject1.bin"/><Relationship Id="rId9" Type="http://schemas.openxmlformats.org/officeDocument/2006/relationships/image" Target="../media/image3.png"/><Relationship Id="rId10" Type="http://schemas.openxmlformats.org/officeDocument/2006/relationships/image" Target="../media/image4.wmf"/><Relationship Id="rId11" Type="http://schemas.openxmlformats.org/officeDocument/2006/relationships/image" Target="../media/image4.wmf"/><Relationship Id="rId12" Type="http://schemas.openxmlformats.org/officeDocument/2006/relationships/image" Target="../media/image5.jpeg"/><Relationship Id="rId13" Type="http://schemas.openxmlformats.org/officeDocument/2006/relationships/image" Target="../media/image5.jpeg"/><Relationship Id="rId14" Type="http://schemas.openxmlformats.org/officeDocument/2006/relationships/image" Target="../media/image6.jpeg"/><Relationship Id="rId15" Type="http://schemas.openxmlformats.org/officeDocument/2006/relationships/image" Target="../media/image7.jpeg"/><Relationship Id="rId16" Type="http://schemas.openxmlformats.org/officeDocument/2006/relationships/image" Target="../media/image6.jpeg"/><Relationship Id="rId17" Type="http://schemas.openxmlformats.org/officeDocument/2006/relationships/image" Target="../media/image7.jpe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57120" y="612720"/>
            <a:ext cx="3059280" cy="2327400"/>
            <a:chOff x="357120" y="612720"/>
            <a:chExt cx="3059280" cy="23274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0" t="16015" r="0" b="0"/>
            <a:stretch/>
          </p:blipFill>
          <p:spPr>
            <a:xfrm flipH="1">
              <a:off x="456840" y="979560"/>
              <a:ext cx="2901960" cy="1892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357120" y="612720"/>
              <a:ext cx="3059280" cy="23274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004400" y="7113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502720" y="74772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93840" y="6602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79520" y="977760"/>
              <a:ext cx="40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X6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944720" y="977760"/>
              <a:ext cx="40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</a:rPr>
                <a:t>X6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"/>
          <p:cNvGrpSpPr/>
          <p:nvPr/>
        </p:nvGrpSpPr>
        <p:grpSpPr>
          <a:xfrm>
            <a:off x="3492360" y="609480"/>
            <a:ext cx="3038760" cy="2328840"/>
            <a:chOff x="3492360" y="609480"/>
            <a:chExt cx="3038760" cy="2328840"/>
          </a:xfrm>
        </p:grpSpPr>
        <p:sp>
          <p:nvSpPr>
            <p:cNvPr id="50" name=""/>
            <p:cNvSpPr/>
            <p:nvPr/>
          </p:nvSpPr>
          <p:spPr>
            <a:xfrm>
              <a:off x="5751000" y="66528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592160" y="6174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492360" y="609480"/>
              <a:ext cx="3038760" cy="23288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558600" y="1231920"/>
              <a:ext cx="56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nt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601440" y="227016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PB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524400" y="65412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2"/>
            <a:srcRect l="52696" t="40705" r="13826" b="34247"/>
            <a:stretch/>
          </p:blipFill>
          <p:spPr>
            <a:xfrm>
              <a:off x="5392800" y="1914480"/>
              <a:ext cx="1066680" cy="988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7" name=""/>
            <p:cNvGrpSpPr/>
            <p:nvPr/>
          </p:nvGrpSpPr>
          <p:grpSpPr>
            <a:xfrm>
              <a:off x="4149720" y="865080"/>
              <a:ext cx="1107720" cy="2025360"/>
              <a:chOff x="4149720" y="865080"/>
              <a:chExt cx="1107720" cy="2025360"/>
            </a:xfrm>
          </p:grpSpPr>
          <p:pic>
            <p:nvPicPr>
              <p:cNvPr id="58" name="" descr=""/>
              <p:cNvPicPr/>
              <p:nvPr/>
            </p:nvPicPr>
            <p:blipFill>
              <a:blip r:embed="rId3"/>
              <a:srcRect l="25050" t="40117" r="45415" b="34247"/>
              <a:stretch/>
            </p:blipFill>
            <p:spPr>
              <a:xfrm>
                <a:off x="4149720" y="1903320"/>
                <a:ext cx="1104120" cy="987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" name="" descr=""/>
              <p:cNvPicPr/>
              <p:nvPr/>
            </p:nvPicPr>
            <p:blipFill>
              <a:blip r:embed="rId4"/>
              <a:srcRect l="25050" t="14873" r="45415" b="60079"/>
              <a:stretch/>
            </p:blipFill>
            <p:spPr>
              <a:xfrm>
                <a:off x="4152960" y="865080"/>
                <a:ext cx="1104480" cy="98892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60" name="" descr=""/>
            <p:cNvPicPr/>
            <p:nvPr/>
          </p:nvPicPr>
          <p:blipFill>
            <a:blip r:embed="rId5"/>
            <a:srcRect l="52696" t="14873" r="13826" b="60079"/>
            <a:stretch/>
          </p:blipFill>
          <p:spPr>
            <a:xfrm>
              <a:off x="5394240" y="868320"/>
              <a:ext cx="1069920" cy="990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1" name=""/>
            <p:cNvGrpSpPr/>
            <p:nvPr/>
          </p:nvGrpSpPr>
          <p:grpSpPr>
            <a:xfrm>
              <a:off x="5297400" y="868320"/>
              <a:ext cx="1106280" cy="2034720"/>
              <a:chOff x="5297400" y="868320"/>
              <a:chExt cx="1106280" cy="2034720"/>
            </a:xfrm>
          </p:grpSpPr>
          <p:pic>
            <p:nvPicPr>
              <p:cNvPr id="62" name="" descr=""/>
              <p:cNvPicPr/>
              <p:nvPr/>
            </p:nvPicPr>
            <p:blipFill>
              <a:blip r:embed="rId6"/>
              <a:srcRect l="52689" t="40705" r="13821" b="34247"/>
              <a:stretch/>
            </p:blipFill>
            <p:spPr>
              <a:xfrm>
                <a:off x="5297400" y="1914840"/>
                <a:ext cx="1104480" cy="988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" descr=""/>
              <p:cNvPicPr/>
              <p:nvPr/>
            </p:nvPicPr>
            <p:blipFill>
              <a:blip r:embed="rId7"/>
              <a:srcRect l="52689" t="14873" r="13821" b="60079"/>
              <a:stretch/>
            </p:blipFill>
            <p:spPr>
              <a:xfrm>
                <a:off x="5297400" y="868320"/>
                <a:ext cx="1106280" cy="98964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64" name=""/>
          <p:cNvSpPr/>
          <p:nvPr/>
        </p:nvSpPr>
        <p:spPr>
          <a:xfrm>
            <a:off x="-123840" y="41400"/>
            <a:ext cx="242892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, 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5" name=""/>
          <p:cNvGrpSpPr/>
          <p:nvPr/>
        </p:nvGrpSpPr>
        <p:grpSpPr>
          <a:xfrm>
            <a:off x="276120" y="2968560"/>
            <a:ext cx="3248280" cy="2470320"/>
            <a:chOff x="276120" y="2968560"/>
            <a:chExt cx="3248280" cy="2470320"/>
          </a:xfrm>
        </p:grpSpPr>
        <p:graphicFrame>
          <p:nvGraphicFramePr>
            <p:cNvPr id="66" name=""/>
            <p:cNvGraphicFramePr/>
            <p:nvPr/>
          </p:nvGraphicFramePr>
          <p:xfrm>
            <a:off x="563400" y="3173400"/>
            <a:ext cx="2961000" cy="2097000"/>
          </p:xfrm>
          <a:graphic>
            <a:graphicData uri="http://schemas.openxmlformats.org/presentationml/2006/ole">
              <p:oleObj r:id="rId8" spid="">
                <p:embed/>
                <p:pic>
                  <p:nvPicPr>
                    <p:cNvPr id="67" name="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563400" y="3173400"/>
                      <a:ext cx="2961000" cy="2097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8" name=""/>
            <p:cNvSpPr/>
            <p:nvPr/>
          </p:nvSpPr>
          <p:spPr>
            <a:xfrm>
              <a:off x="371520" y="296856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99480" y="3071880"/>
              <a:ext cx="274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ranspiration of isolated cuticle fragmen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-136440" y="4020480"/>
              <a:ext cx="119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ermeance (m/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170080" y="3346560"/>
              <a:ext cx="162000" cy="73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979720" y="3641760"/>
              <a:ext cx="163440" cy="147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63560" y="5241960"/>
              <a:ext cx="2649600" cy="74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7720" bIns="2772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956520" y="5203800"/>
              <a:ext cx="48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-B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413000" y="5203800"/>
              <a:ext cx="38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y-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716840" y="520380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-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107080" y="5203800"/>
              <a:ext cx="38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425320" y="520380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WT-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832840" y="5203800"/>
              <a:ext cx="40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6120" y="3060720"/>
              <a:ext cx="914400" cy="914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43080" y="2981160"/>
              <a:ext cx="3076560" cy="24577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71880" y="3429000"/>
              <a:ext cx="247320" cy="88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876400" y="3743280"/>
              <a:ext cx="247680" cy="88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3456000" y="2959200"/>
            <a:ext cx="3087720" cy="2668320"/>
            <a:chOff x="3456000" y="2959200"/>
            <a:chExt cx="3087720" cy="2668320"/>
          </a:xfrm>
        </p:grpSpPr>
        <p:pic>
          <p:nvPicPr>
            <p:cNvPr id="85" name="" descr=""/>
            <p:cNvPicPr/>
            <p:nvPr/>
          </p:nvPicPr>
          <p:blipFill>
            <a:blip r:embed="rId10"/>
            <a:srcRect l="9344" t="14006" r="-410" b="12322"/>
            <a:stretch/>
          </p:blipFill>
          <p:spPr>
            <a:xfrm>
              <a:off x="3637080" y="3157560"/>
              <a:ext cx="289692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"/>
            <p:cNvSpPr/>
            <p:nvPr/>
          </p:nvSpPr>
          <p:spPr>
            <a:xfrm>
              <a:off x="6512040" y="3060720"/>
              <a:ext cx="0" cy="256680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973840" y="3090960"/>
              <a:ext cx="466560" cy="404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8" name="" descr=""/>
            <p:cNvPicPr/>
            <p:nvPr/>
          </p:nvPicPr>
          <p:blipFill>
            <a:blip r:embed="rId11"/>
            <a:srcRect l="82534" t="2497" r="1211" b="72194"/>
            <a:stretch/>
          </p:blipFill>
          <p:spPr>
            <a:xfrm>
              <a:off x="5969160" y="3189240"/>
              <a:ext cx="519120" cy="65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"/>
            <p:cNvSpPr/>
            <p:nvPr/>
          </p:nvSpPr>
          <p:spPr>
            <a:xfrm>
              <a:off x="3465720" y="29592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6200000">
              <a:off x="2760120" y="3984480"/>
              <a:ext cx="163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eight (% from harves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927240" y="3048120"/>
              <a:ext cx="2117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resh wight of post harvest frui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674600" y="5232240"/>
              <a:ext cx="1334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s post anthe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467160" y="2990880"/>
              <a:ext cx="3076560" cy="245736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"/>
          <p:cNvGrpSpPr/>
          <p:nvPr/>
        </p:nvGrpSpPr>
        <p:grpSpPr>
          <a:xfrm>
            <a:off x="351000" y="5452920"/>
            <a:ext cx="3065400" cy="2914920"/>
            <a:chOff x="351000" y="5452920"/>
            <a:chExt cx="3065400" cy="2914920"/>
          </a:xfrm>
        </p:grpSpPr>
        <p:grpSp>
          <p:nvGrpSpPr>
            <p:cNvPr id="95" name=""/>
            <p:cNvGrpSpPr/>
            <p:nvPr/>
          </p:nvGrpSpPr>
          <p:grpSpPr>
            <a:xfrm>
              <a:off x="696960" y="5765760"/>
              <a:ext cx="2641320" cy="2547720"/>
              <a:chOff x="696960" y="5765760"/>
              <a:chExt cx="2641320" cy="2547720"/>
            </a:xfrm>
          </p:grpSpPr>
          <p:pic>
            <p:nvPicPr>
              <p:cNvPr id="96" name="" descr=""/>
              <p:cNvPicPr/>
              <p:nvPr/>
            </p:nvPicPr>
            <p:blipFill>
              <a:blip r:embed="rId12"/>
              <a:srcRect l="9312" t="28343" r="51319" b="26891"/>
              <a:stretch/>
            </p:blipFill>
            <p:spPr>
              <a:xfrm>
                <a:off x="696960" y="5765760"/>
                <a:ext cx="1281240" cy="1238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" descr=""/>
              <p:cNvPicPr/>
              <p:nvPr/>
            </p:nvPicPr>
            <p:blipFill>
              <a:blip r:embed="rId13"/>
              <a:srcRect l="58415" t="31266" r="7195" b="28630"/>
              <a:stretch/>
            </p:blipFill>
            <p:spPr>
              <a:xfrm>
                <a:off x="2057040" y="5765760"/>
                <a:ext cx="1281240" cy="1238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8" name="" descr=""/>
              <p:cNvPicPr/>
              <p:nvPr/>
            </p:nvPicPr>
            <p:blipFill>
              <a:blip r:embed="rId14"/>
              <a:srcRect l="17615" t="0" r="15683" b="0"/>
              <a:stretch/>
            </p:blipFill>
            <p:spPr>
              <a:xfrm>
                <a:off x="696960" y="7074000"/>
                <a:ext cx="1281240" cy="1238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9" name="" descr=""/>
              <p:cNvPicPr/>
              <p:nvPr/>
            </p:nvPicPr>
            <p:blipFill>
              <a:blip r:embed="rId15"/>
              <a:srcRect l="25427" t="0" r="15855" b="1817"/>
              <a:stretch/>
            </p:blipFill>
            <p:spPr>
              <a:xfrm>
                <a:off x="2057040" y="7075440"/>
                <a:ext cx="1281240" cy="1238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0" name="" descr=""/>
              <p:cNvPicPr/>
              <p:nvPr/>
            </p:nvPicPr>
            <p:blipFill>
              <a:blip r:embed="rId16">
                <a:lum bright="-18000"/>
              </a:blip>
              <a:srcRect l="17615" t="0" r="15683" b="0"/>
              <a:stretch/>
            </p:blipFill>
            <p:spPr>
              <a:xfrm>
                <a:off x="696960" y="7074000"/>
                <a:ext cx="1281240" cy="1238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1" name="" descr=""/>
              <p:cNvPicPr/>
              <p:nvPr/>
            </p:nvPicPr>
            <p:blipFill>
              <a:blip r:embed="rId17">
                <a:lum bright="-18000"/>
              </a:blip>
              <a:srcRect l="25427" t="0" r="15855" b="1817"/>
              <a:stretch/>
            </p:blipFill>
            <p:spPr>
              <a:xfrm>
                <a:off x="2057040" y="7075440"/>
                <a:ext cx="1281240" cy="12380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02" name=""/>
            <p:cNvSpPr/>
            <p:nvPr/>
          </p:nvSpPr>
          <p:spPr>
            <a:xfrm>
              <a:off x="351000" y="5489640"/>
              <a:ext cx="3065400" cy="2878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485440" y="551484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73320" y="547200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108080" y="5452920"/>
              <a:ext cx="297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3:37:13Z</dcterms:modified>
  <cp:revision>2</cp:revision>
  <dc:subject/>
  <dc:title>Slide 1</dc:title>
</cp:coreProperties>
</file>